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788" y="-84"/>
      </p:cViewPr>
      <p:guideLst>
        <p:guide orient="horz" pos="2160"/>
        <p:guide orient="horz" pos="3067"/>
        <p:guide pos="2880"/>
        <p:guide pos="476"/>
        <p:guide pos="505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关于14-3-3蛋白\OsGF14b的实验结果\GF14b论文写作及孙欣娇毕业论文\GF14b论文写作\short communication整理图片\GF14b干旱处理表达量变化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85918" y="1071546"/>
            <a:ext cx="4959858" cy="3473196"/>
          </a:xfrm>
          <a:prstGeom prst="rect">
            <a:avLst/>
          </a:prstGeom>
          <a:noFill/>
        </p:spPr>
      </p:pic>
      <p:sp>
        <p:nvSpPr>
          <p:cNvPr id="5" name="矩形 4"/>
          <p:cNvSpPr/>
          <p:nvPr/>
        </p:nvSpPr>
        <p:spPr>
          <a:xfrm>
            <a:off x="785786" y="4753463"/>
            <a:ext cx="728667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Figure S1 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Expression levels of OsGF14b under soil drought stress treatment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Seedlings (3.5- to 4.5-leaf stage) were subjected to soil drought stress treatment. Relative expression level of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OsGF14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were examined by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-PCR. The rice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Actin1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gene was used as the internal control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rror bars represent the SE of three replicates (**,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&lt; 0.01, by Student’s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test)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F:\关于14-3-3蛋白\OsGF14b的实验结果\GF14b论文写作及孙欣娇毕业论文\GF14b论文写作\short communication整理图片\基因结构+突变体基因型鉴定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19862" y="1357298"/>
            <a:ext cx="6838286" cy="2714644"/>
          </a:xfrm>
          <a:prstGeom prst="rect">
            <a:avLst/>
          </a:prstGeom>
          <a:noFill/>
        </p:spPr>
      </p:pic>
      <p:sp>
        <p:nvSpPr>
          <p:cNvPr id="6" name="矩形 5"/>
          <p:cNvSpPr/>
          <p:nvPr/>
        </p:nvSpPr>
        <p:spPr>
          <a:xfrm>
            <a:off x="741312" y="4429132"/>
            <a:ext cx="7286676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Figure S2 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Schematic diagram of the </a:t>
            </a:r>
            <a:r>
              <a:rPr lang="en-US" sz="1200" i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OsGF14b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gene and PCR-based genotyping for the </a:t>
            </a:r>
            <a:r>
              <a:rPr lang="en-US" sz="1200" i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osgf14b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homozygous mutant. </a:t>
            </a:r>
            <a:r>
              <a:rPr lang="en-US" sz="1200" b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a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Schematic diagram of the </a:t>
            </a:r>
            <a:r>
              <a:rPr lang="en-US" sz="1200" i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OsGF14b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gene. In the genomic DNA, </a:t>
            </a:r>
            <a:r>
              <a:rPr lang="en-US" sz="1200" kern="0" dirty="0" err="1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exons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, </a:t>
            </a:r>
            <a:r>
              <a:rPr lang="en-US" sz="1200" kern="0" dirty="0" err="1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introns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, and </a:t>
            </a:r>
            <a:r>
              <a:rPr lang="en-US" sz="1200" kern="0" dirty="0" err="1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untranslated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regions are indicated by black boxes, lines between boxes, and white boxes, respectively. The T-DNA insertion site is located in the promoter, 745 </a:t>
            </a:r>
            <a:r>
              <a:rPr lang="en-US" sz="1200" kern="0" dirty="0" err="1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bp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upstream of the start </a:t>
            </a:r>
            <a:r>
              <a:rPr lang="en-US" sz="1200" kern="0" dirty="0" err="1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codon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ATG. LB, left border; RB, right border. Arrows mF, </a:t>
            </a:r>
            <a:r>
              <a:rPr lang="en-US" sz="1200" kern="0" dirty="0" err="1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mR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, and mV represent the primers used in the genotyping of the </a:t>
            </a:r>
            <a:r>
              <a:rPr lang="en-US" sz="1200" i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osgf14b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mutant. </a:t>
            </a:r>
            <a:r>
              <a:rPr lang="en-US" sz="1200" b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b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PCR-based genotyping for the </a:t>
            </a:r>
            <a:r>
              <a:rPr lang="en-US" sz="1200" i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osgf14b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homozygous mutant. </a:t>
            </a:r>
          </a:p>
          <a:p>
            <a:pPr algn="just">
              <a:lnSpc>
                <a:spcPct val="150000"/>
              </a:lnSpc>
            </a:pP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F:\关于14-3-3蛋白\OsGF14b的实验结果\GF14b论文写作及孙欣娇毕业论文\GF14b论文写作\short communication整理图片\GF14b short communication\第一次修改\修改时找的新数据\气孔导度\突变体和过表达气孔导度整理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5650" y="1205676"/>
            <a:ext cx="7272338" cy="2509076"/>
          </a:xfrm>
          <a:prstGeom prst="rect">
            <a:avLst/>
          </a:prstGeom>
          <a:noFill/>
        </p:spPr>
      </p:pic>
      <p:sp>
        <p:nvSpPr>
          <p:cNvPr id="6" name="矩形 5"/>
          <p:cNvSpPr/>
          <p:nvPr/>
        </p:nvSpPr>
        <p:spPr>
          <a:xfrm>
            <a:off x="741312" y="4143380"/>
            <a:ext cx="728667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Figure S3 </a:t>
            </a:r>
            <a:r>
              <a:rPr lang="en-US" sz="1200" kern="0" dirty="0" err="1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Stomatal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 conductance of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e WT and transgenic plants (mutant and OE) under normal growth and drought stress conditions. Error bars represent the SE of three biological replicates 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(5 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plants in each replicate)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Statistical differences are labeled with different letters according to the LSD test (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&lt; 0.05, one-way ANOVA)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关于14-3-3蛋白\OsGF14b的实验结果\GF14b论文写作及孙欣娇毕业论文\GF14b论文写作\short communication整理图片\GF14b short communication\第一次修改\修改时找的新数据\GF14b萌发结果\种子萌发结果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5650" y="1295161"/>
            <a:ext cx="7333787" cy="2633905"/>
          </a:xfrm>
          <a:prstGeom prst="rect">
            <a:avLst/>
          </a:prstGeom>
          <a:noFill/>
        </p:spPr>
      </p:pic>
      <p:sp>
        <p:nvSpPr>
          <p:cNvPr id="6" name="矩形 5"/>
          <p:cNvSpPr/>
          <p:nvPr/>
        </p:nvSpPr>
        <p:spPr>
          <a:xfrm>
            <a:off x="741312" y="4143380"/>
            <a:ext cx="728667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Figure S4 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Seeds germination rate of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e WT and transgenic lines (mutant and OE) on normal medium and 10% PEG4000 supplemented-medium. Error bars represent the SE of three biological replicates </a:t>
            </a:r>
            <a:r>
              <a:rPr lang="en-US" sz="1200" kern="0" dirty="0" smtClean="0">
                <a:solidFill>
                  <a:prstClr val="black"/>
                </a:solidFill>
                <a:latin typeface="Times New Roman" pitchFamily="18" charset="0"/>
                <a:ea typeface="宋体"/>
                <a:cs typeface="Times New Roman" pitchFamily="18" charset="0"/>
              </a:rPr>
              <a:t>(100 seeds in each replicate)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3</TotalTime>
  <Words>275</Words>
  <PresentationFormat>全屏显示(4:3)</PresentationFormat>
  <Paragraphs>4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jpliu</dc:creator>
  <cp:lastModifiedBy>lenovo</cp:lastModifiedBy>
  <cp:revision>44</cp:revision>
  <dcterms:created xsi:type="dcterms:W3CDTF">2019-07-25T02:30:27Z</dcterms:created>
  <dcterms:modified xsi:type="dcterms:W3CDTF">2019-10-20T10:45:01Z</dcterms:modified>
</cp:coreProperties>
</file>